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3521C-09A8-4239-8151-731BAC872F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86E9A-DD12-44BB-AE95-76D3F55E31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B54C1-38BD-406B-B6FF-3D237DC1A7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9799F-EAF9-42B1-9A5F-D26A4C2BEF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A16DD-E16F-4B07-8BCC-B2E42BDFE4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FB7EC-F7E9-4478-BE81-BEDFF54339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E4EBC-E70E-401A-8495-88A1072254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941C5-5E88-41B2-8755-324658C300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EABD9-1D71-4D72-8A5B-D94E0E4F66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71754-6B95-488C-B911-2B5F2CBE63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41AD2-0CC3-4411-B5BB-1E046E48E7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48105-1DE0-49DC-BF06-CDCA6C6CF2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ADEA03-BF75-4A87-9798-4968A1DCEB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19320" y="19810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276720" y="19810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495680" y="19810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019920" y="2209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905120" y="914400"/>
            <a:ext cx="205740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ammalian control eleme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85800" y="1676520"/>
            <a:ext cx="2057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ab in PAX243 Fab vect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74720" y="1981080"/>
            <a:ext cx="5778360" cy="343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Light chain variable/constant region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Bacterial element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Heavy chain variable/ IgG CH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                                           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66680" y="2209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05120" y="1143000"/>
            <a:ext cx="1371600" cy="838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962520" y="1143000"/>
            <a:ext cx="533160" cy="838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95280" y="38098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352680" y="38098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724280" y="38098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172200" y="4038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00280" y="4267080"/>
            <a:ext cx="6743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fi I  Xba I                                       Sac I  Not I Nhe I          Hind III Xho I                         Age I 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819520" y="53341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267080" y="53341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171880" y="5562720"/>
            <a:ext cx="285732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ind III  Sfi I                             Age I 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181160" y="4114800"/>
            <a:ext cx="1638360" cy="12193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4267080" y="4114800"/>
            <a:ext cx="1905120" cy="12193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85800" y="4648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gG expression vector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05320" y="2743200"/>
            <a:ext cx="0" cy="487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505320" y="5867280"/>
            <a:ext cx="0" cy="48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143000" y="4038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74720" y="3809880"/>
            <a:ext cx="5778360" cy="343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Light chain variable/constant region         Mammalian elements       Heavy chain variable/ IgG CH1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19040" y="2362320"/>
            <a:ext cx="674388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fi I  Xba I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ac I   Not I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Xho I                            Age I 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143000" y="4952880"/>
            <a:ext cx="5321160" cy="48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Mammalian control                                                                                IgG1 CH1, hinge, CH2, CH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elemen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895480" y="2209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048120" y="4038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3581280" y="40381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419720" y="4038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362320" y="53341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676520" y="7162920"/>
            <a:ext cx="0" cy="571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124080" y="7162920"/>
            <a:ext cx="0" cy="571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191120" y="7162920"/>
            <a:ext cx="0" cy="571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56272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52388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85800" y="6858000"/>
            <a:ext cx="2057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ngineered IgG (eIgG)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38080" y="7162920"/>
            <a:ext cx="548640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Mammalian                Light chain                       Mammalian              Heavy chain variable/ IgG CH1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elements           variable/constant region             elements                             hinge, CH2, CH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38080" y="7696080"/>
            <a:ext cx="548640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ind III  Sfi I  Xba I                    SacI Not I Nhe I   Hind III Xho I                         Age I 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89548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27672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29528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886200" y="7467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-25560" y="121428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566640" y="837720"/>
            <a:ext cx="180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-23760" y="2430360"/>
            <a:ext cx="18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600"/>
            </a:b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-23760" y="3034440"/>
            <a:ext cx="2156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44680" y="2742840"/>
            <a:ext cx="446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90680" y="6187320"/>
            <a:ext cx="180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600"/>
            </a:b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-25560" y="562284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1T17:00:46Z</dcterms:created>
  <dc:creator>Computing Resources Group</dc:creator>
  <dc:description/>
  <dc:language>en-US</dc:language>
  <cp:lastModifiedBy>Computing Resources Group</cp:lastModifiedBy>
  <dcterms:modified xsi:type="dcterms:W3CDTF">2010-01-19T21:44:39Z</dcterms:modified>
  <cp:revision>7</cp:revision>
  <dc:subject/>
  <dc:title>Slide 1</dc:title>
</cp:coreProperties>
</file>